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bin" ContentType="application/vnd.openxmlformats-officedocument.presentationml.printerSettings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it-IT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00FF00"/>
    <a:srgbClr val="B429FF"/>
    <a:srgbClr val="FF8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essuno stile, nessuna grigli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3C2FFA5D-87B4-456A-9821-1D502468CF0F}" styleName="Stile con tema 1 - Colore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284E427A-3D55-4303-BF80-6455036E1DE7}" styleName="Stile con tema 1 - Colore 2">
    <a:tblBg>
      <a:fillRef idx="2">
        <a:schemeClr val="accent2"/>
      </a:fillRef>
      <a:effectRef idx="1">
        <a:schemeClr val="accent2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Ref idx="1">
              <a:schemeClr val="accent2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  <a:fill>
          <a:solidFill>
            <a:schemeClr val="accent2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2"/>
            </a:lnRef>
          </a:left>
          <a:right>
            <a:lnRef idx="2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2">
              <a:schemeClr val="accent2"/>
            </a:lnRef>
          </a:top>
          <a:bottom>
            <a:lnRef idx="2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2"/>
          </a:solidFill>
        </a:fill>
      </a:tcStyle>
    </a:firstRow>
  </a:tblStyle>
  <a:tblStyle styleId="{69C7853C-536D-4A76-A0AE-DD22124D55A5}" styleName="Stile con tema 1 - Colore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10" d="100"/>
          <a:sy n="10" d="100"/>
        </p:scale>
        <p:origin x="-1864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imac:Library:Mail%20Downloads:isotgrammi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imac:Library:Mail%20Downloads:isotgrammi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it-IT" dirty="0"/>
              <a:t>TRG </a:t>
            </a:r>
            <a:r>
              <a:rPr lang="it-IT" dirty="0" err="1"/>
              <a:t>cDNA</a:t>
            </a:r>
            <a:endParaRPr lang="it-IT" dirty="0"/>
          </a:p>
        </c:rich>
      </c:tx>
      <c:layout/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Foglio1!$C$2</c:f>
              <c:strCache>
                <c:ptCount val="1"/>
                <c:pt idx="0">
                  <c:v>in-fram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Foglio1!$B$3:$B$8</c:f>
              <c:strCache>
                <c:ptCount val="6"/>
                <c:pt idx="0">
                  <c:v>V1 J2</c:v>
                </c:pt>
                <c:pt idx="1">
                  <c:v>V1 J1</c:v>
                </c:pt>
                <c:pt idx="2">
                  <c:v>V1 J3</c:v>
                </c:pt>
                <c:pt idx="3">
                  <c:v>V2 J3</c:v>
                </c:pt>
                <c:pt idx="4">
                  <c:v>V2 J1</c:v>
                </c:pt>
                <c:pt idx="5">
                  <c:v>V2 J2</c:v>
                </c:pt>
              </c:strCache>
            </c:strRef>
          </c:cat>
          <c:val>
            <c:numRef>
              <c:f>Foglio1!$C$3:$C$8</c:f>
              <c:numCache>
                <c:formatCode>General</c:formatCode>
                <c:ptCount val="6"/>
                <c:pt idx="0">
                  <c:v>16.0</c:v>
                </c:pt>
                <c:pt idx="1">
                  <c:v>1.0</c:v>
                </c:pt>
                <c:pt idx="2">
                  <c:v>6.0</c:v>
                </c:pt>
                <c:pt idx="3">
                  <c:v>11.0</c:v>
                </c:pt>
                <c:pt idx="4">
                  <c:v>4.0</c:v>
                </c:pt>
                <c:pt idx="5">
                  <c:v>1.0</c:v>
                </c:pt>
              </c:numCache>
            </c:numRef>
          </c:val>
        </c:ser>
        <c:ser>
          <c:idx val="1"/>
          <c:order val="1"/>
          <c:tx>
            <c:strRef>
              <c:f>Foglio1!$D$2</c:f>
              <c:strCache>
                <c:ptCount val="1"/>
                <c:pt idx="0">
                  <c:v>out-of-frame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Foglio1!$B$3:$B$8</c:f>
              <c:strCache>
                <c:ptCount val="6"/>
                <c:pt idx="0">
                  <c:v>V1 J2</c:v>
                </c:pt>
                <c:pt idx="1">
                  <c:v>V1 J1</c:v>
                </c:pt>
                <c:pt idx="2">
                  <c:v>V1 J3</c:v>
                </c:pt>
                <c:pt idx="3">
                  <c:v>V2 J3</c:v>
                </c:pt>
                <c:pt idx="4">
                  <c:v>V2 J1</c:v>
                </c:pt>
                <c:pt idx="5">
                  <c:v>V2 J2</c:v>
                </c:pt>
              </c:strCache>
            </c:strRef>
          </c:cat>
          <c:val>
            <c:numRef>
              <c:f>Foglio1!$D$3:$D$8</c:f>
              <c:numCache>
                <c:formatCode>General</c:formatCode>
                <c:ptCount val="6"/>
                <c:pt idx="0">
                  <c:v>1.0</c:v>
                </c:pt>
                <c:pt idx="1">
                  <c:v>0.0</c:v>
                </c:pt>
                <c:pt idx="2">
                  <c:v>0.0</c:v>
                </c:pt>
                <c:pt idx="3">
                  <c:v>11.0</c:v>
                </c:pt>
                <c:pt idx="4">
                  <c:v>8.0</c:v>
                </c:pt>
                <c:pt idx="5">
                  <c:v>0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091842024"/>
        <c:axId val="2119793928"/>
      </c:barChart>
      <c:catAx>
        <c:axId val="20918420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2119793928"/>
        <c:crosses val="autoZero"/>
        <c:auto val="1"/>
        <c:lblAlgn val="ctr"/>
        <c:lblOffset val="100"/>
        <c:noMultiLvlLbl val="0"/>
      </c:catAx>
      <c:valAx>
        <c:axId val="211979392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209184202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it-IT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it-IT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it-IT" dirty="0"/>
              <a:t>TRG </a:t>
            </a:r>
            <a:r>
              <a:rPr lang="it-IT" dirty="0" err="1"/>
              <a:t>genomic</a:t>
            </a:r>
            <a:r>
              <a:rPr lang="it-IT" dirty="0"/>
              <a:t> </a:t>
            </a:r>
            <a:r>
              <a:rPr lang="it-IT" dirty="0" smtClean="0"/>
              <a:t>DNA</a:t>
            </a:r>
            <a:endParaRPr lang="it-IT" dirty="0"/>
          </a:p>
        </c:rich>
      </c:tx>
      <c:layout/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Foglio1!$C$10</c:f>
              <c:strCache>
                <c:ptCount val="1"/>
                <c:pt idx="0">
                  <c:v>in-fram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Foglio1!$B$11:$B$12</c:f>
              <c:strCache>
                <c:ptCount val="2"/>
                <c:pt idx="0">
                  <c:v>V1 J2</c:v>
                </c:pt>
                <c:pt idx="1">
                  <c:v>V2 J3</c:v>
                </c:pt>
              </c:strCache>
            </c:strRef>
          </c:cat>
          <c:val>
            <c:numRef>
              <c:f>Foglio1!$C$11:$C$12</c:f>
              <c:numCache>
                <c:formatCode>General</c:formatCode>
                <c:ptCount val="2"/>
                <c:pt idx="0">
                  <c:v>9.0</c:v>
                </c:pt>
                <c:pt idx="1">
                  <c:v>5.0</c:v>
                </c:pt>
              </c:numCache>
            </c:numRef>
          </c:val>
        </c:ser>
        <c:ser>
          <c:idx val="1"/>
          <c:order val="1"/>
          <c:tx>
            <c:strRef>
              <c:f>Foglio1!$D$10</c:f>
              <c:strCache>
                <c:ptCount val="1"/>
                <c:pt idx="0">
                  <c:v>out-of-frame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Foglio1!$B$11:$B$12</c:f>
              <c:strCache>
                <c:ptCount val="2"/>
                <c:pt idx="0">
                  <c:v>V1 J2</c:v>
                </c:pt>
                <c:pt idx="1">
                  <c:v>V2 J3</c:v>
                </c:pt>
              </c:strCache>
            </c:strRef>
          </c:cat>
          <c:val>
            <c:numRef>
              <c:f>Foglio1!$D$11:$D$12</c:f>
              <c:numCache>
                <c:formatCode>General</c:formatCode>
                <c:ptCount val="2"/>
                <c:pt idx="0">
                  <c:v>0.0</c:v>
                </c:pt>
                <c:pt idx="1">
                  <c:v>18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119186040"/>
        <c:axId val="2094253576"/>
      </c:barChart>
      <c:catAx>
        <c:axId val="21191860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2094253576"/>
        <c:crosses val="autoZero"/>
        <c:auto val="1"/>
        <c:lblAlgn val="ctr"/>
        <c:lblOffset val="100"/>
        <c:noMultiLvlLbl val="0"/>
      </c:catAx>
      <c:valAx>
        <c:axId val="209425357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211918604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it-IT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it-IT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622F6-F86C-2744-BA3C-19E2A5075A0B}" type="datetimeFigureOut">
              <a:rPr lang="it-IT" smtClean="0"/>
              <a:t>03/08/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BA488-3C52-4E41-8A67-753279CFEF22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246096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622F6-F86C-2744-BA3C-19E2A5075A0B}" type="datetimeFigureOut">
              <a:rPr lang="it-IT" smtClean="0"/>
              <a:t>03/08/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BA488-3C52-4E41-8A67-753279CFEF22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638600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verticale e tes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622F6-F86C-2744-BA3C-19E2A5075A0B}" type="datetimeFigureOut">
              <a:rPr lang="it-IT" smtClean="0"/>
              <a:t>03/08/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BA488-3C52-4E41-8A67-753279CFEF22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155106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622F6-F86C-2744-BA3C-19E2A5075A0B}" type="datetimeFigureOut">
              <a:rPr lang="it-IT" smtClean="0"/>
              <a:t>03/08/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BA488-3C52-4E41-8A67-753279CFEF22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395555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622F6-F86C-2744-BA3C-19E2A5075A0B}" type="datetimeFigureOut">
              <a:rPr lang="it-IT" smtClean="0"/>
              <a:t>03/08/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BA488-3C52-4E41-8A67-753279CFEF22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171911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nuto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622F6-F86C-2744-BA3C-19E2A5075A0B}" type="datetimeFigureOut">
              <a:rPr lang="it-IT" smtClean="0"/>
              <a:t>03/08/1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BA488-3C52-4E41-8A67-753279CFEF22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76316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622F6-F86C-2744-BA3C-19E2A5075A0B}" type="datetimeFigureOut">
              <a:rPr lang="it-IT" smtClean="0"/>
              <a:t>03/08/15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BA488-3C52-4E41-8A67-753279CFEF22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330200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622F6-F86C-2744-BA3C-19E2A5075A0B}" type="datetimeFigureOut">
              <a:rPr lang="it-IT" smtClean="0"/>
              <a:t>03/08/15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BA488-3C52-4E41-8A67-753279CFEF22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772659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622F6-F86C-2744-BA3C-19E2A5075A0B}" type="datetimeFigureOut">
              <a:rPr lang="it-IT" smtClean="0"/>
              <a:t>03/08/15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BA488-3C52-4E41-8A67-753279CFEF22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558280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622F6-F86C-2744-BA3C-19E2A5075A0B}" type="datetimeFigureOut">
              <a:rPr lang="it-IT" smtClean="0"/>
              <a:t>03/08/1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BA488-3C52-4E41-8A67-753279CFEF22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881973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622F6-F86C-2744-BA3C-19E2A5075A0B}" type="datetimeFigureOut">
              <a:rPr lang="it-IT" smtClean="0"/>
              <a:t>03/08/1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BA488-3C52-4E41-8A67-753279CFEF22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275119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A622F6-F86C-2744-BA3C-19E2A5075A0B}" type="datetimeFigureOut">
              <a:rPr lang="it-IT" smtClean="0"/>
              <a:t>03/08/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4BA488-3C52-4E41-8A67-753279CFEF22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580879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.xml"/><Relationship Id="rId3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Grafico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15088502"/>
              </p:ext>
            </p:extLst>
          </p:nvPr>
        </p:nvGraphicFramePr>
        <p:xfrm>
          <a:off x="338142" y="1981737"/>
          <a:ext cx="5016500" cy="2590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Grafico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45225487"/>
              </p:ext>
            </p:extLst>
          </p:nvPr>
        </p:nvGraphicFramePr>
        <p:xfrm>
          <a:off x="5649198" y="1981737"/>
          <a:ext cx="2219577" cy="2590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Rettangolo 3"/>
          <p:cNvSpPr/>
          <p:nvPr/>
        </p:nvSpPr>
        <p:spPr>
          <a:xfrm>
            <a:off x="358023" y="1578339"/>
            <a:ext cx="31822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dirty="0" smtClean="0"/>
              <a:t>A</a:t>
            </a:r>
            <a:endParaRPr lang="it-IT" dirty="0"/>
          </a:p>
        </p:txBody>
      </p:sp>
      <p:sp>
        <p:nvSpPr>
          <p:cNvPr id="5" name="Rettangolo 4"/>
          <p:cNvSpPr/>
          <p:nvPr/>
        </p:nvSpPr>
        <p:spPr>
          <a:xfrm>
            <a:off x="5748899" y="1611329"/>
            <a:ext cx="31822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dirty="0" smtClean="0"/>
              <a:t>B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182852771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1</TotalTime>
  <Words>7</Words>
  <Application>Microsoft Macintosh PowerPoint</Application>
  <PresentationFormat>Presentazione su schermo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di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di PowerPoint</dc:title>
  <dc:creator>GT</dc:creator>
  <cp:lastModifiedBy>macbookpro</cp:lastModifiedBy>
  <cp:revision>31</cp:revision>
  <cp:lastPrinted>2015-04-27T21:17:03Z</cp:lastPrinted>
  <dcterms:created xsi:type="dcterms:W3CDTF">2014-07-07T16:08:10Z</dcterms:created>
  <dcterms:modified xsi:type="dcterms:W3CDTF">2015-08-03T10:20:47Z</dcterms:modified>
</cp:coreProperties>
</file>